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AB9C87D-9364-1D4C-AA7B-E4F797558DC2}" v="22" dt="2025-03-25T13:27:08.3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73"/>
    <p:restoredTop sz="94670"/>
  </p:normalViewPr>
  <p:slideViewPr>
    <p:cSldViewPr snapToGrid="0">
      <p:cViewPr varScale="1">
        <p:scale>
          <a:sx n="152" d="100"/>
          <a:sy n="152" d="100"/>
        </p:scale>
        <p:origin x="2504" y="168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13" Type="http://schemas.microsoft.com/office/2015/10/relationships/revisionInfo" Target="revisionInfo.xml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emf"/><Relationship Id="rId4" Type="http://schemas.openxmlformats.org/officeDocument/2006/relationships/image" Target="../media/image2.png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"/>
          <p:cNvSpPr txBox="1"/>
          <p:nvPr/>
        </p:nvSpPr>
        <p:spPr>
          <a:xfrm>
            <a:off x="11944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99" name="Google Shape;99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"/>
          <p:cNvSpPr/>
          <p:nvPr/>
        </p:nvSpPr>
        <p:spPr>
          <a:xfrm>
            <a:off x="-9788" y="1549155"/>
            <a:ext cx="9144000" cy="4329038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1" name="Google Shape;101;p1"/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/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 dirty="0" err="1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</a:t>
              </a:r>
              <a:r>
                <a:rPr lang="en-US" sz="1725" b="1" i="0" u="none" strike="noStrike" cap="none" dirty="0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     @</a:t>
              </a:r>
              <a:r>
                <a:rPr lang="en-US" sz="1725" b="1" i="0" u="none" strike="noStrike" cap="none" dirty="0" err="1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BMJ</a:t>
              </a:r>
              <a:endParaRPr sz="1725" b="1" i="0" u="none" strike="noStrike" cap="none" dirty="0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/>
          <p:cNvSpPr/>
          <p:nvPr/>
        </p:nvSpPr>
        <p:spPr>
          <a:xfrm>
            <a:off x="-8228" y="396804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105319" y="379250"/>
            <a:ext cx="8796361" cy="9348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>
              <a:buSzPts val="1575"/>
            </a:pPr>
            <a:r>
              <a:rPr lang="en-GB" sz="18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riability in sensitivity to inflammation in muscle and lung of patients with COPD may underly susceptibility to lung function decline</a:t>
            </a:r>
            <a:endParaRPr lang="en-GB" sz="18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endParaRPr sz="1575" b="1" u="none" strike="noStrike" cap="none" dirty="0">
              <a:solidFill>
                <a:schemeClr val="bg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6" name="Google Shape;106;p1"/>
          <p:cNvSpPr txBox="1"/>
          <p:nvPr/>
        </p:nvSpPr>
        <p:spPr>
          <a:xfrm>
            <a:off x="388690" y="1728069"/>
            <a:ext cx="2262173" cy="307736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GB"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ETHODS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1"/>
          <p:cNvSpPr txBox="1"/>
          <p:nvPr/>
        </p:nvSpPr>
        <p:spPr>
          <a:xfrm>
            <a:off x="3167816" y="1739919"/>
            <a:ext cx="2808368" cy="307736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GB"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RESULTS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8" name="Google Shape;108;p1"/>
          <p:cNvSpPr txBox="1"/>
          <p:nvPr/>
        </p:nvSpPr>
        <p:spPr>
          <a:xfrm>
            <a:off x="6493107" y="1733993"/>
            <a:ext cx="2408573" cy="307736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GB"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NCLUSION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9" name="Google Shape;109;p1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sp>
        <p:nvSpPr>
          <p:cNvPr id="125" name="Rectangle 124">
            <a:extLst>
              <a:ext uri="{FF2B5EF4-FFF2-40B4-BE49-F238E27FC236}">
                <a16:creationId xmlns:a16="http://schemas.microsoft.com/office/drawing/2014/main" id="{473D2257-77EE-7668-9464-0112BCDDD4C6}"/>
              </a:ext>
            </a:extLst>
          </p:cNvPr>
          <p:cNvSpPr/>
          <p:nvPr/>
        </p:nvSpPr>
        <p:spPr>
          <a:xfrm>
            <a:off x="6293224" y="2117912"/>
            <a:ext cx="2681130" cy="35433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1" name="Picture 120">
            <a:extLst>
              <a:ext uri="{FF2B5EF4-FFF2-40B4-BE49-F238E27FC236}">
                <a16:creationId xmlns:a16="http://schemas.microsoft.com/office/drawing/2014/main" id="{0ACC3209-2730-7628-2C1A-210F029600C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53734" y="2217149"/>
            <a:ext cx="2607385" cy="3126649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123" name="Rectangle 122">
            <a:extLst>
              <a:ext uri="{FF2B5EF4-FFF2-40B4-BE49-F238E27FC236}">
                <a16:creationId xmlns:a16="http://schemas.microsoft.com/office/drawing/2014/main" id="{C691A16C-D8A1-ABFB-BBD9-CFA590418A10}"/>
              </a:ext>
            </a:extLst>
          </p:cNvPr>
          <p:cNvSpPr/>
          <p:nvPr/>
        </p:nvSpPr>
        <p:spPr>
          <a:xfrm>
            <a:off x="221648" y="2117912"/>
            <a:ext cx="2561024" cy="35433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22" name="Picture 121">
            <a:extLst>
              <a:ext uri="{FF2B5EF4-FFF2-40B4-BE49-F238E27FC236}">
                <a16:creationId xmlns:a16="http://schemas.microsoft.com/office/drawing/2014/main" id="{097188E4-895D-E857-3858-5F890DEBAB8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5127" y="2313116"/>
            <a:ext cx="2543093" cy="2830384"/>
          </a:xfrm>
          <a:prstGeom prst="rect">
            <a:avLst/>
          </a:prstGeom>
        </p:spPr>
      </p:pic>
      <p:sp>
        <p:nvSpPr>
          <p:cNvPr id="124" name="Rectangle 123">
            <a:extLst>
              <a:ext uri="{FF2B5EF4-FFF2-40B4-BE49-F238E27FC236}">
                <a16:creationId xmlns:a16="http://schemas.microsoft.com/office/drawing/2014/main" id="{17D5CB64-0AB7-6F7C-6128-CFFD50D6BDE5}"/>
              </a:ext>
            </a:extLst>
          </p:cNvPr>
          <p:cNvSpPr/>
          <p:nvPr/>
        </p:nvSpPr>
        <p:spPr>
          <a:xfrm>
            <a:off x="2992458" y="2117912"/>
            <a:ext cx="3159085" cy="354330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0" name="Picture 129">
            <a:extLst>
              <a:ext uri="{FF2B5EF4-FFF2-40B4-BE49-F238E27FC236}">
                <a16:creationId xmlns:a16="http://schemas.microsoft.com/office/drawing/2014/main" id="{52139855-992B-EA1F-0580-D34E65759E2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06829" y="2139232"/>
            <a:ext cx="3126537" cy="349975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085DFF9-9096-E3B9-31A2-FDAC1A311214}"/>
              </a:ext>
            </a:extLst>
          </p:cNvPr>
          <p:cNvSpPr txBox="1"/>
          <p:nvPr/>
        </p:nvSpPr>
        <p:spPr>
          <a:xfrm>
            <a:off x="221648" y="5439426"/>
            <a:ext cx="15343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FFMI=Fat free mass index</a:t>
            </a:r>
          </a:p>
        </p:txBody>
      </p:sp>
      <p:sp>
        <p:nvSpPr>
          <p:cNvPr id="4" name="Google Shape;98;p1">
            <a:extLst>
              <a:ext uri="{FF2B5EF4-FFF2-40B4-BE49-F238E27FC236}">
                <a16:creationId xmlns:a16="http://schemas.microsoft.com/office/drawing/2014/main" id="{802D45B2-E087-8E65-09F4-BB4C76E59FAD}"/>
              </a:ext>
            </a:extLst>
          </p:cNvPr>
          <p:cNvSpPr txBox="1"/>
          <p:nvPr/>
        </p:nvSpPr>
        <p:spPr>
          <a:xfrm>
            <a:off x="9900" y="1132715"/>
            <a:ext cx="9144000" cy="4500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25" b="0" i="0" u="none" strike="noStrike" cap="none" dirty="0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rPr>
              <a:t>Kemp PR, et al. </a:t>
            </a:r>
            <a:r>
              <a:rPr lang="en-US" sz="1425" b="0" i="1" u="none" strike="noStrike" cap="none" dirty="0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rPr>
              <a:t>Thorax </a:t>
            </a:r>
            <a:r>
              <a:rPr lang="en-US" sz="1425" b="0" i="0" u="none" strike="noStrike" cap="none" dirty="0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rPr>
              <a:t>2025. DOI: 10.1136/thorax-2025-221901</a:t>
            </a:r>
            <a:endParaRPr sz="1275" b="0" i="0" u="none" strike="noStrike" cap="none" dirty="0">
              <a:solidFill>
                <a:srgbClr val="1C4587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 dirty="0">
              <a:solidFill>
                <a:srgbClr val="1C4587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</TotalTime>
  <Words>53</Words>
  <Application>Microsoft Macintosh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olantonio</dc:creator>
  <cp:lastModifiedBy>Kemp, Paul</cp:lastModifiedBy>
  <cp:revision>3</cp:revision>
  <dcterms:created xsi:type="dcterms:W3CDTF">2018-02-16T17:34:16Z</dcterms:created>
  <dcterms:modified xsi:type="dcterms:W3CDTF">2025-04-01T11:36:03Z</dcterms:modified>
</cp:coreProperties>
</file>